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7" d="100"/>
          <a:sy n="37" d="100"/>
        </p:scale>
        <p:origin x="207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068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576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931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5711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7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81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790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6807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81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852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0397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0333A-7263-41F7-958B-58E31D64C149}" type="datetimeFigureOut">
              <a:rPr lang="en-GB" smtClean="0"/>
              <a:t>3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54FCC-FDA9-450D-BF64-52624AC53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5227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50EEA18-EFF4-D2E6-EA85-DCE0889B3271}"/>
              </a:ext>
            </a:extLst>
          </p:cNvPr>
          <p:cNvSpPr txBox="1"/>
          <p:nvPr/>
        </p:nvSpPr>
        <p:spPr>
          <a:xfrm>
            <a:off x="176191" y="258619"/>
            <a:ext cx="1760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77ED24-6923-DA01-8549-8C9AF5D7D3C9}"/>
              </a:ext>
            </a:extLst>
          </p:cNvPr>
          <p:cNvSpPr txBox="1"/>
          <p:nvPr/>
        </p:nvSpPr>
        <p:spPr>
          <a:xfrm>
            <a:off x="0" y="4424553"/>
            <a:ext cx="64952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DNA sequences from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C1-A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hromosome 5A),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C1-B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hromosome 5B) 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C1-D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hromosome 5D), showing the positions of guide RNA sequences gRNA1 (top) and gRNA2 (bottom) and their D-genome specific PAM sequences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16F0D5C-1D7B-809D-52B4-54A8751F6347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b="35832"/>
          <a:stretch/>
        </p:blipFill>
        <p:spPr>
          <a:xfrm>
            <a:off x="76201" y="898239"/>
            <a:ext cx="6706181" cy="10679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FC112B2-80A3-402D-41A4-D1D246069E93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b="22953"/>
          <a:stretch/>
        </p:blipFill>
        <p:spPr>
          <a:xfrm>
            <a:off x="76201" y="2675802"/>
            <a:ext cx="6706181" cy="108505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316864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8</TotalTime>
  <Words>47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Norwich Bioscience Institut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diye Hayta (JIC)</dc:creator>
  <cp:lastModifiedBy>Amy Tighe</cp:lastModifiedBy>
  <cp:revision>9</cp:revision>
  <dcterms:created xsi:type="dcterms:W3CDTF">2023-07-04T17:23:31Z</dcterms:created>
  <dcterms:modified xsi:type="dcterms:W3CDTF">2023-07-31T13:56:44Z</dcterms:modified>
</cp:coreProperties>
</file>